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206988" cy="34204275"/>
  <p:notesSz cx="678656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55F4A-A236-4BC0-86CA-5459155453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3888396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60360" y="19771560"/>
            <a:ext cx="3888396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BADB4-8FE9-4ECE-AE53-D881C74410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084920" y="798048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60360" y="1977156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084920" y="1977156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6F689-4FC2-4390-BF61-1D2D5EDC41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125204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307200" y="7980480"/>
            <a:ext cx="125204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454040" y="7980480"/>
            <a:ext cx="125204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60360" y="19771560"/>
            <a:ext cx="125204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307200" y="19771560"/>
            <a:ext cx="125204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454040" y="19771560"/>
            <a:ext cx="125204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84DAD-E609-4BE3-BFF9-C5BD3FAC0E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60360" y="7980480"/>
            <a:ext cx="38883960" cy="2257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424"/>
              </a:spcBef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DD02D-FCE7-4B3B-BF5E-86F287ADEA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38883960" cy="2257416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1F824-D1F4-40F0-BA6A-49B0D040EE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18975240" cy="2257416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084920" y="7980480"/>
            <a:ext cx="18975240" cy="2257416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4D070-C14B-4F70-8C31-98F696C14E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471E0-F195-4E7B-BEC8-90F39A7958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60360" y="1369800"/>
            <a:ext cx="38883960" cy="2642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424"/>
              </a:spcBef>
              <a:tabLst>
                <a:tab algn="l" pos="0"/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F63FB-8645-4557-9B97-6123F98CAE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084920" y="7980480"/>
            <a:ext cx="18975240" cy="2257416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60360" y="1977156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1E699-F9BF-4652-8EB2-756DFB7139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18975240" cy="2257416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084920" y="798048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084920" y="1977156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51529-B3E8-43F3-A839-3DAA1EB832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60360" y="798048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084920" y="7980480"/>
            <a:ext cx="1897524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60360" y="19771560"/>
            <a:ext cx="38883960" cy="10767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indent="0">
              <a:spcBef>
                <a:spcPts val="3424"/>
              </a:spcBef>
              <a:buNone/>
              <a:tabLst>
                <a:tab algn="l" pos="3908520"/>
                <a:tab algn="l" pos="7816680"/>
              </a:tabLst>
            </a:pP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EABB1-DB89-4115-9F4A-E1736D202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60360" y="1369800"/>
            <a:ext cx="38883960" cy="570060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 algn="ctr">
              <a:buNone/>
              <a:tabLst>
                <a:tab algn="l" pos="0"/>
                <a:tab algn="l" pos="3908520"/>
                <a:tab algn="l" pos="7816680"/>
              </a:tabLst>
            </a:pPr>
            <a:r>
              <a:rPr b="0" lang="en-US" sz="18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60360" y="7980480"/>
            <a:ext cx="38883960" cy="2257416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t">
            <a:normAutofit/>
          </a:bodyPr>
          <a:p>
            <a:pPr marL="1465200" indent="-1465200">
              <a:spcBef>
                <a:spcPts val="3424"/>
              </a:spcBef>
              <a:buClr>
                <a:srgbClr val="000000"/>
              </a:buClr>
              <a:buFont typeface="Arial"/>
              <a:buChar char="•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  <a:p>
            <a:pPr lvl="1" marL="3174840" indent="-1220760">
              <a:spcBef>
                <a:spcPts val="3424"/>
              </a:spcBef>
              <a:buClr>
                <a:srgbClr val="000000"/>
              </a:buClr>
              <a:buFont typeface="Arial"/>
              <a:buChar char="–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  <a:p>
            <a:pPr lvl="2" marL="4886280" indent="-976320">
              <a:spcBef>
                <a:spcPts val="3424"/>
              </a:spcBef>
              <a:buClr>
                <a:srgbClr val="000000"/>
              </a:buClr>
              <a:buFont typeface="Arial"/>
              <a:buChar char="•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  <a:p>
            <a:pPr lvl="3" marL="6840360" indent="-975960">
              <a:spcBef>
                <a:spcPts val="3424"/>
              </a:spcBef>
              <a:buClr>
                <a:srgbClr val="000000"/>
              </a:buClr>
              <a:buFont typeface="Arial"/>
              <a:buChar char="–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  <a:p>
            <a:pPr lvl="4" marL="8794800" indent="-976320">
              <a:spcBef>
                <a:spcPts val="3424"/>
              </a:spcBef>
              <a:buClr>
                <a:srgbClr val="000000"/>
              </a:buClr>
              <a:buFont typeface="Arial"/>
              <a:buChar char="»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  <a:p>
            <a:pPr lvl="5" marL="8794800" indent="-976320">
              <a:spcBef>
                <a:spcPts val="3424"/>
              </a:spcBef>
              <a:buClr>
                <a:srgbClr val="000000"/>
              </a:buClr>
              <a:buFont typeface="Arial"/>
              <a:buChar char="»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  <a:p>
            <a:pPr lvl="6" marL="8794800" indent="-976320">
              <a:spcBef>
                <a:spcPts val="3424"/>
              </a:spcBef>
              <a:buClr>
                <a:srgbClr val="000000"/>
              </a:buClr>
              <a:buFont typeface="Arial"/>
              <a:buChar char="»"/>
              <a:tabLst>
                <a:tab algn="l" pos="3908520"/>
                <a:tab algn="l" pos="781668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60360" y="31702320"/>
            <a:ext cx="10080360" cy="182088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3908520"/>
                <a:tab algn="l" pos="7816680"/>
              </a:tabLst>
              <a:defRPr b="0" lang="it-IT" sz="5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3908520"/>
                <a:tab algn="l" pos="7816680"/>
              </a:tabLst>
            </a:pPr>
            <a:r>
              <a:rPr b="0" lang="it-IT" sz="5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761800" y="31702320"/>
            <a:ext cx="13681080" cy="182088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p>
            <a:pPr indent="0">
              <a:buNone/>
              <a:tabLst>
                <a:tab algn="l" pos="0"/>
                <a:tab algn="l" pos="3908520"/>
                <a:tab algn="l" pos="7816680"/>
              </a:tabLst>
            </a:pPr>
            <a:endParaRPr b="0" lang="en-US" sz="7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963960" y="31702320"/>
            <a:ext cx="10080360" cy="1820880"/>
          </a:xfrm>
          <a:prstGeom prst="rect">
            <a:avLst/>
          </a:prstGeom>
          <a:noFill/>
          <a:ln w="0">
            <a:noFill/>
          </a:ln>
        </p:spPr>
        <p:txBody>
          <a:bodyPr lIns="390960" rIns="390960" tIns="195480" bIns="1954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3908520"/>
                <a:tab algn="l" pos="7816680"/>
              </a:tabLst>
              <a:defRPr b="0" lang="it-IT" sz="5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3908520"/>
                <a:tab algn="l" pos="7816680"/>
              </a:tabLst>
            </a:pPr>
            <a:fld id="{5AFD69DA-5AE0-4A2E-90D9-90E9B0E84E56}" type="slidenum">
              <a:rPr b="0" lang="it-IT" sz="5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44720" y="5221440"/>
          <a:ext cx="35663040" cy="11448720"/>
        </p:xfrm>
        <a:graphic>
          <a:graphicData uri="http://schemas.openxmlformats.org/drawingml/2006/table">
            <a:tbl>
              <a:tblPr/>
              <a:tblGrid>
                <a:gridCol w="5646600"/>
                <a:gridCol w="23130000"/>
                <a:gridCol w="6886440"/>
              </a:tblGrid>
              <a:tr h="11444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1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ene Symbol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1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ull name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1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thylation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4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LC2A9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olute Carrier Family 2 Facilitated Glucose Transporter Member 9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o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62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RIM15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ripartite motif-containing protein 15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o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IPA1L1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ignal-induced proliferation-associated 1-like protein 1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o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4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KAR1B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otein Kinase CAMP-Dependent Type I Regulatory Subunit Beta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er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4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EK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ceptor Tyrosine Kinase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er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RVI1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urine Retrovirus Integration Site 1 Homolog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er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62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KCTD11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tassium Channel Tetramerization Domain Containing 11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er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4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GK494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Uncharacterized serine/threonine-protein kinase SgK494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er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440"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it-IT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KCNJ16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tassium Inwardly Rectifying Channel Subfamily J Member 16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47840" rIns="44784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3908520"/>
                          <a:tab algn="l" pos="7816680"/>
                        </a:tabLst>
                      </a:pPr>
                      <a:r>
                        <a:rPr b="0" lang="en-US" sz="65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yper-methylated</a:t>
                      </a:r>
                      <a:endParaRPr b="0" lang="en-US" sz="6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47840" marR="447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CasellaDiTesto 4"/>
          <p:cNvSpPr/>
          <p:nvPr/>
        </p:nvSpPr>
        <p:spPr>
          <a:xfrm>
            <a:off x="2448000" y="2197080"/>
            <a:ext cx="22610520" cy="192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08520"/>
                <a:tab algn="l" pos="7816680"/>
              </a:tabLst>
            </a:pPr>
            <a:r>
              <a:rPr b="1" lang="it-IT" sz="6000" spc="-1" strike="noStrike">
                <a:solidFill>
                  <a:srgbClr val="000000"/>
                </a:solidFill>
                <a:latin typeface="Arial"/>
                <a:ea typeface="Arial"/>
              </a:rPr>
              <a:t>Supplementary </a:t>
            </a:r>
            <a:r>
              <a:rPr b="1" lang="en-US" sz="6000" spc="-1" strike="noStrike">
                <a:solidFill>
                  <a:srgbClr val="000000"/>
                </a:solidFill>
                <a:latin typeface="Arial"/>
                <a:ea typeface="Arial"/>
              </a:rPr>
              <a:t>Table S9 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3908520"/>
                <a:tab algn="l" pos="781668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  <a:ea typeface="Arial"/>
              </a:rPr>
              <a:t>“</a:t>
            </a:r>
            <a:r>
              <a:rPr b="0" lang="en-US" sz="6000" spc="-1" strike="noStrike">
                <a:solidFill>
                  <a:srgbClr val="000000"/>
                </a:solidFill>
                <a:latin typeface="Arial"/>
                <a:ea typeface="Arial"/>
              </a:rPr>
              <a:t>Stable genes” in T5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8-23T07:56:52Z</dcterms:created>
  <dc:creator>Stefania</dc:creator>
  <dc:description/>
  <dc:language>en-US</dc:language>
  <cp:lastModifiedBy>Ilaria Laurenzana</cp:lastModifiedBy>
  <dcterms:modified xsi:type="dcterms:W3CDTF">2023-02-27T09:05:37Z</dcterms:modified>
  <cp:revision>235</cp:revision>
  <dc:subject/>
  <dc:title>Diapositiva 1</dc:title>
</cp:coreProperties>
</file>